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7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266" autoAdjust="0"/>
    <p:restoredTop sz="94660"/>
  </p:normalViewPr>
  <p:slideViewPr>
    <p:cSldViewPr snapToGrid="0">
      <p:cViewPr varScale="1">
        <p:scale>
          <a:sx n="88" d="100"/>
          <a:sy n="88" d="100"/>
        </p:scale>
        <p:origin x="415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441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6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962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623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795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844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122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205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95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346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89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61FC3-9E1E-4EA0-A591-5B4982915CA8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40008-D498-4752-888F-784C93FF15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638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3CBA7A9-B9D0-F251-E6A5-FD7648D4FB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0734930"/>
              </p:ext>
            </p:extLst>
          </p:nvPr>
        </p:nvGraphicFramePr>
        <p:xfrm>
          <a:off x="222811" y="326897"/>
          <a:ext cx="6422200" cy="9195816"/>
        </p:xfrm>
        <a:graphic>
          <a:graphicData uri="http://schemas.openxmlformats.org/drawingml/2006/table">
            <a:tbl>
              <a:tblPr firstRow="1" bandRow="1" bandCol="1">
                <a:tableStyleId>{2D5ABB26-0587-4C30-8999-92F81FD0307C}</a:tableStyleId>
              </a:tblPr>
              <a:tblGrid>
                <a:gridCol w="4432316">
                  <a:extLst>
                    <a:ext uri="{9D8B030D-6E8A-4147-A177-3AD203B41FA5}">
                      <a16:colId xmlns:a16="http://schemas.microsoft.com/office/drawing/2014/main" val="1967680691"/>
                    </a:ext>
                  </a:extLst>
                </a:gridCol>
                <a:gridCol w="1080655">
                  <a:extLst>
                    <a:ext uri="{9D8B030D-6E8A-4147-A177-3AD203B41FA5}">
                      <a16:colId xmlns:a16="http://schemas.microsoft.com/office/drawing/2014/main" val="1441186016"/>
                    </a:ext>
                  </a:extLst>
                </a:gridCol>
                <a:gridCol w="909229">
                  <a:extLst>
                    <a:ext uri="{9D8B030D-6E8A-4147-A177-3AD203B41FA5}">
                      <a16:colId xmlns:a16="http://schemas.microsoft.com/office/drawing/2014/main" val="789884105"/>
                    </a:ext>
                  </a:extLst>
                </a:gridCol>
              </a:tblGrid>
              <a:tr h="38661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us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ty (%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milarity (%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607783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Homo sapien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Human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1142648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Mus musculu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use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8521769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t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vegic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rown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1625713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Bos tauru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attle)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8184723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Ovi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e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heep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120173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Sus scrofa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g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3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9181357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Gallus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lus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hicken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113364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G.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fayettii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ri Lanka Junglefowl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107281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darcis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ffonei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eolian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ll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zard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6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57245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Sceloporus undulatu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Eastern fence lizard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3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72162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Xenopus laevi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frican clawed frog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3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5236731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Rana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mporari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ommon frog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5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1097555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lorhinch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ii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host shark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361268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oscylli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gios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spotted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mbooshark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5091489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lyraj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diat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Thorny skate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5778516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nephelus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scoguttatus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rown-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bled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er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6300783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unn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acare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llowfin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una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315776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Alosa alos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llis shad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283717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hysur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lvidraco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llow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fish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9493595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talur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unctatu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hannel catfish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9475315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Cyprinu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pio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ommon carp)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4465069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Danio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rio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brafish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00881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Gadu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hua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lantic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d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6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6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9956297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Salmo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a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lantic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mon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9674804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Oncorhynchus mykis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inbow trout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0564987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Hippocampu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sterae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Dwarf seahorse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5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2474236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opter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p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umpfish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672744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Sebastes </a:t>
                      </a:r>
                      <a:r>
                        <a:rPr lang="de-DE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hlegelii</a:t>
                      </a:r>
                      <a:r>
                        <a:rPr lang="de-DE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Korean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ckfish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3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5135679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Epinephelu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ioide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Orange-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tted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er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5873445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atomus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rnacchii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Emerald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ckcod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2401575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es-E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es-E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s-E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centrarchus</a:t>
                      </a:r>
                      <a:r>
                        <a:rPr lang="es-E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rax</a:t>
                      </a:r>
                      <a:r>
                        <a:rPr lang="es-E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ropea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bass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3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5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21958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pholatil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maeleonticep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eat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thern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lefish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254222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kifugu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bripe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ese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fferfish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pt-BR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9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9058416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tjan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ru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acific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pper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51444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tjan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guine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phead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apper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1559461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Thunnus thynnu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tlantic bluefin tuna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5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5694688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irtothrip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orsalis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lli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hrips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9180716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Seriola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landi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llowtail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erjack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it-IT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0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8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18683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hiprion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ellaris</a:t>
                      </a:r>
                      <a:r>
                        <a:rPr lang="it-IT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ellaris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wnfish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7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2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104129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eciliops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ic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ackstripe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bearer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3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5811587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arifer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ophthalm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pt-BR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s</a:t>
                      </a:r>
                      <a:r>
                        <a:rPr lang="pt-BR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rbot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pt-BR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6988120"/>
                  </a:ext>
                </a:extLst>
              </a:tr>
              <a:tr h="20974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. calcarifer V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pogloss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pogloss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tlantic halibut)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1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4</a:t>
                      </a: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888499"/>
                  </a:ext>
                </a:extLst>
              </a:tr>
            </a:tbl>
          </a:graphicData>
        </a:graphic>
      </p:graphicFrame>
      <p:sp>
        <p:nvSpPr>
          <p:cNvPr id="4" name="กล่องข้อความ 2">
            <a:extLst>
              <a:ext uri="{FF2B5EF4-FFF2-40B4-BE49-F238E27FC236}">
                <a16:creationId xmlns:a16="http://schemas.microsoft.com/office/drawing/2014/main" id="{2B6355F2-539D-43D2-EA48-49EF76FFCCAB}"/>
              </a:ext>
            </a:extLst>
          </p:cNvPr>
          <p:cNvSpPr txBox="1"/>
          <p:nvPr/>
        </p:nvSpPr>
        <p:spPr>
          <a:xfrm>
            <a:off x="222811" y="0"/>
            <a:ext cx="3225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Document Table. S1</a:t>
            </a:r>
            <a:endParaRPr lang="th-TH" sz="14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4326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กล่องข้อความ 2">
            <a:extLst>
              <a:ext uri="{FF2B5EF4-FFF2-40B4-BE49-F238E27FC236}">
                <a16:creationId xmlns:a16="http://schemas.microsoft.com/office/drawing/2014/main" id="{7E3A02F3-D8DF-8341-7BEC-87BE3AD9A2CB}"/>
              </a:ext>
            </a:extLst>
          </p:cNvPr>
          <p:cNvSpPr txBox="1"/>
          <p:nvPr/>
        </p:nvSpPr>
        <p:spPr>
          <a:xfrm>
            <a:off x="222811" y="0"/>
            <a:ext cx="431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Document Figure. S1 (Figure 8B)</a:t>
            </a:r>
            <a:endParaRPr lang="th-TH" sz="1400" dirty="0">
              <a:latin typeface="Arial" panose="020B0604020202020204" pitchFamily="34" charset="0"/>
            </a:endParaRPr>
          </a:p>
        </p:txBody>
      </p:sp>
      <p:pic>
        <p:nvPicPr>
          <p:cNvPr id="4" name="Picture 3" descr="A blue and white image&#10;&#10;AI-generated content may be incorrect.">
            <a:extLst>
              <a:ext uri="{FF2B5EF4-FFF2-40B4-BE49-F238E27FC236}">
                <a16:creationId xmlns:a16="http://schemas.microsoft.com/office/drawing/2014/main" id="{54F50AC5-78FA-B197-5440-0E895CD3A3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925" y="382639"/>
            <a:ext cx="5611932" cy="4624515"/>
          </a:xfrm>
          <a:prstGeom prst="rect">
            <a:avLst/>
          </a:prstGeom>
        </p:spPr>
      </p:pic>
      <p:pic>
        <p:nvPicPr>
          <p:cNvPr id="6" name="Picture 5" descr="A close-up of a white paper&#10;&#10;AI-generated content may be incorrect.">
            <a:extLst>
              <a:ext uri="{FF2B5EF4-FFF2-40B4-BE49-F238E27FC236}">
                <a16:creationId xmlns:a16="http://schemas.microsoft.com/office/drawing/2014/main" id="{1B18109B-5709-9F00-5C39-68F015D547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6170" y="5210627"/>
            <a:ext cx="2740658" cy="4388635"/>
          </a:xfrm>
          <a:prstGeom prst="rect">
            <a:avLst/>
          </a:prstGeom>
        </p:spPr>
      </p:pic>
      <p:pic>
        <p:nvPicPr>
          <p:cNvPr id="8" name="Picture 7" descr="A close up of a test&#10;&#10;AI-generated content may be incorrect.">
            <a:extLst>
              <a:ext uri="{FF2B5EF4-FFF2-40B4-BE49-F238E27FC236}">
                <a16:creationId xmlns:a16="http://schemas.microsoft.com/office/drawing/2014/main" id="{1D1FD18B-E859-61D0-38AF-2257902F1F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925" y="5210627"/>
            <a:ext cx="2026904" cy="4388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2962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67</TotalTime>
  <Words>522</Words>
  <Application>Microsoft Macintosh PowerPoint</Application>
  <PresentationFormat>A4 Paper (210x297 mm)</PresentationFormat>
  <Paragraphs>13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yanee MUANGRERK</dc:creator>
  <cp:lastModifiedBy>Prapansak Srisapoome</cp:lastModifiedBy>
  <cp:revision>29</cp:revision>
  <dcterms:created xsi:type="dcterms:W3CDTF">2023-09-23T07:08:05Z</dcterms:created>
  <dcterms:modified xsi:type="dcterms:W3CDTF">2025-12-26T04:47:49Z</dcterms:modified>
</cp:coreProperties>
</file>